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48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ko-KR" smtClean="0"/>
              <a:t>Click to edit Master subtitle style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857D18-399F-4514-AB83-9390830D5F3A}" type="datetimeFigureOut">
              <a:rPr lang="ko-KR" altLang="en-US" smtClean="0"/>
              <a:t>2017-1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BC6BF-0515-4013-B116-9CDFB7203D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3850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857D18-399F-4514-AB83-9390830D5F3A}" type="datetimeFigureOut">
              <a:rPr lang="ko-KR" altLang="en-US" smtClean="0"/>
              <a:t>2017-1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BC6BF-0515-4013-B116-9CDFB7203D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4681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857D18-399F-4514-AB83-9390830D5F3A}" type="datetimeFigureOut">
              <a:rPr lang="ko-KR" altLang="en-US" smtClean="0"/>
              <a:t>2017-1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BC6BF-0515-4013-B116-9CDFB7203D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8510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857D18-399F-4514-AB83-9390830D5F3A}" type="datetimeFigureOut">
              <a:rPr lang="ko-KR" altLang="en-US" smtClean="0"/>
              <a:t>2017-1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BC6BF-0515-4013-B116-9CDFB7203D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93534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857D18-399F-4514-AB83-9390830D5F3A}" type="datetimeFigureOut">
              <a:rPr lang="ko-KR" altLang="en-US" smtClean="0"/>
              <a:t>2017-1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BC6BF-0515-4013-B116-9CDFB7203D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325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857D18-399F-4514-AB83-9390830D5F3A}" type="datetimeFigureOut">
              <a:rPr lang="ko-KR" altLang="en-US" smtClean="0"/>
              <a:t>2017-11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BC6BF-0515-4013-B116-9CDFB7203D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6787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857D18-399F-4514-AB83-9390830D5F3A}" type="datetimeFigureOut">
              <a:rPr lang="ko-KR" altLang="en-US" smtClean="0"/>
              <a:t>2017-11-3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BC6BF-0515-4013-B116-9CDFB7203D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2966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857D18-399F-4514-AB83-9390830D5F3A}" type="datetimeFigureOut">
              <a:rPr lang="ko-KR" altLang="en-US" smtClean="0"/>
              <a:t>2017-11-3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BC6BF-0515-4013-B116-9CDFB7203D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72233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857D18-399F-4514-AB83-9390830D5F3A}" type="datetimeFigureOut">
              <a:rPr lang="ko-KR" altLang="en-US" smtClean="0"/>
              <a:t>2017-11-3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BC6BF-0515-4013-B116-9CDFB7203D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91618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857D18-399F-4514-AB83-9390830D5F3A}" type="datetimeFigureOut">
              <a:rPr lang="ko-KR" altLang="en-US" smtClean="0"/>
              <a:t>2017-11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BC6BF-0515-4013-B116-9CDFB7203D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40852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857D18-399F-4514-AB83-9390830D5F3A}" type="datetimeFigureOut">
              <a:rPr lang="ko-KR" altLang="en-US" smtClean="0"/>
              <a:t>2017-11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BC6BF-0515-4013-B116-9CDFB7203D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0955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857D18-399F-4514-AB83-9390830D5F3A}" type="datetimeFigureOut">
              <a:rPr lang="ko-KR" altLang="en-US" smtClean="0"/>
              <a:t>2017-1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ABC6BF-0515-4013-B116-9CDFB7203D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4480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EEN2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6"/>
          <a:srcRect l="30026" t="38056" r="22742" b="12897"/>
          <a:stretch/>
        </p:blipFill>
        <p:spPr>
          <a:xfrm>
            <a:off x="2631183" y="1748042"/>
            <a:ext cx="2303370" cy="2391881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3651416" y="3936713"/>
            <a:ext cx="1180800" cy="14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TextBox 6"/>
          <p:cNvSpPr txBox="1"/>
          <p:nvPr/>
        </p:nvSpPr>
        <p:spPr>
          <a:xfrm>
            <a:off x="4166956" y="3567381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olidFill>
                  <a:schemeClr val="bg1"/>
                </a:solidFill>
              </a:rPr>
              <a:t>5 </a:t>
            </a:r>
            <a:r>
              <a:rPr lang="en-US" altLang="ko-KR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altLang="ko-KR" dirty="0" smtClean="0">
                <a:solidFill>
                  <a:schemeClr val="bg1"/>
                </a:solidFill>
              </a:rPr>
              <a:t>m</a:t>
            </a:r>
            <a:endParaRPr lang="ko-KR" altLang="en-US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631183" y="1748042"/>
            <a:ext cx="532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solidFill>
                  <a:schemeClr val="bg1"/>
                </a:solidFill>
              </a:rPr>
              <a:t>S1</a:t>
            </a:r>
            <a:endParaRPr lang="ko-KR" altLang="en-US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61549" y="4542194"/>
            <a:ext cx="10892901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ovie S1. A 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low surface cover ratio of RBC membranes to Si 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articles, which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hows the partial debris of 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luorescence  </a:t>
            </a:r>
            <a:b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lipids (DMPE-</a:t>
            </a:r>
            <a:r>
              <a:rPr lang="en-US" altLang="ko-KR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hB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) labeled membranes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ubstrates.</a:t>
            </a:r>
          </a:p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ovie S2. A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high surface cover ratio of RBC membranes to Si particles with the successful translocation of the 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BC </a:t>
            </a:r>
            <a:b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membrane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onto 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the surface of particles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Series010_chan00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7"/>
          <a:srcRect l="60661" t="8333" b="52080"/>
          <a:stretch>
            <a:fillRect/>
          </a:stretch>
        </p:blipFill>
        <p:spPr>
          <a:xfrm>
            <a:off x="5793095" y="1709092"/>
            <a:ext cx="2415600" cy="2430831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7632379" y="3922909"/>
            <a:ext cx="487068" cy="1578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TextBox 8"/>
          <p:cNvSpPr txBox="1"/>
          <p:nvPr/>
        </p:nvSpPr>
        <p:spPr>
          <a:xfrm>
            <a:off x="7511097" y="3494367"/>
            <a:ext cx="914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solidFill>
                  <a:schemeClr val="bg1"/>
                </a:solidFill>
              </a:rPr>
              <a:t>5 </a:t>
            </a:r>
            <a:r>
              <a:rPr lang="en-US" altLang="ko-KR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altLang="ko-KR" dirty="0" smtClean="0">
                <a:solidFill>
                  <a:schemeClr val="bg1"/>
                </a:solidFill>
              </a:rPr>
              <a:t>m</a:t>
            </a:r>
            <a:endParaRPr lang="ko-KR" altLang="en-US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801973" y="1745416"/>
            <a:ext cx="532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solidFill>
                  <a:schemeClr val="bg1"/>
                </a:solidFill>
              </a:rPr>
              <a:t>S2</a:t>
            </a:r>
            <a:endParaRPr lang="ko-KR" altLang="en-US" dirty="0">
              <a:solidFill>
                <a:schemeClr val="bg1"/>
              </a:solidFill>
            </a:endParaRPr>
          </a:p>
        </p:txBody>
      </p:sp>
      <p:sp>
        <p:nvSpPr>
          <p:cNvPr id="16" name="Title 1"/>
          <p:cNvSpPr txBox="1">
            <a:spLocks/>
          </p:cNvSpPr>
          <p:nvPr/>
        </p:nvSpPr>
        <p:spPr>
          <a:xfrm>
            <a:off x="636233" y="255776"/>
            <a:ext cx="9144000" cy="855540"/>
          </a:xfrm>
          <a:prstGeom prst="rect">
            <a:avLst/>
          </a:prstGeom>
        </p:spPr>
        <p:txBody>
          <a:bodyPr>
            <a:normAutofit fontScale="97500"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mtClean="0"/>
              <a:t>Supporting Informatio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10002778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3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0</Words>
  <Application>Microsoft Office PowerPoint</Application>
  <PresentationFormat>Widescreen</PresentationFormat>
  <Paragraphs>7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orting Information</dc:title>
  <dc:creator>USER</dc:creator>
  <cp:lastModifiedBy>USER</cp:lastModifiedBy>
  <cp:revision>2</cp:revision>
  <dcterms:created xsi:type="dcterms:W3CDTF">2017-11-29T08:18:59Z</dcterms:created>
  <dcterms:modified xsi:type="dcterms:W3CDTF">2017-11-30T03:22:35Z</dcterms:modified>
</cp:coreProperties>
</file>